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555794F-26C8-AE6E-BA29-A197D76CDEE4}" name="Lone Niedziella" initials="LN" userId="S::au82849@uni.au.dk::66582a08-b725-4b2e-823e-ca09cabf91f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74" d="100"/>
          <a:sy n="74" d="100"/>
        </p:scale>
        <p:origin x="2316" y="72"/>
      </p:cViewPr>
      <p:guideLst>
        <p:guide orient="horz" pos="384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tte Amalie Nebsbjerg" userId="49cc1974-8113-4dc3-957b-d53c518f6152" providerId="ADAL" clId="{C4029A96-ED16-4068-B8E2-B5AEFA90D7C7}"/>
    <pc:docChg chg="undo custSel modSld">
      <pc:chgData name="Mette Amalie Nebsbjerg" userId="49cc1974-8113-4dc3-957b-d53c518f6152" providerId="ADAL" clId="{C4029A96-ED16-4068-B8E2-B5AEFA90D7C7}" dt="2023-08-24T13:53:58.914" v="60" actId="20577"/>
      <pc:docMkLst>
        <pc:docMk/>
      </pc:docMkLst>
      <pc:sldChg chg="modSp mod delCm modCm">
        <pc:chgData name="Mette Amalie Nebsbjerg" userId="49cc1974-8113-4dc3-957b-d53c518f6152" providerId="ADAL" clId="{C4029A96-ED16-4068-B8E2-B5AEFA90D7C7}" dt="2023-08-24T13:53:58.914" v="60" actId="20577"/>
        <pc:sldMkLst>
          <pc:docMk/>
          <pc:sldMk cId="3070381831" sldId="259"/>
        </pc:sldMkLst>
        <pc:spChg chg="mod">
          <ac:chgData name="Mette Amalie Nebsbjerg" userId="49cc1974-8113-4dc3-957b-d53c518f6152" providerId="ADAL" clId="{C4029A96-ED16-4068-B8E2-B5AEFA90D7C7}" dt="2023-08-24T13:52:10.914" v="14" actId="20577"/>
          <ac:spMkLst>
            <pc:docMk/>
            <pc:sldMk cId="3070381831" sldId="259"/>
            <ac:spMk id="5" creationId="{9479F0B9-FEBF-D449-2280-BD42F666176A}"/>
          </ac:spMkLst>
        </pc:spChg>
        <pc:spChg chg="mod">
          <ac:chgData name="Mette Amalie Nebsbjerg" userId="49cc1974-8113-4dc3-957b-d53c518f6152" providerId="ADAL" clId="{C4029A96-ED16-4068-B8E2-B5AEFA90D7C7}" dt="2023-08-24T13:52:58.516" v="17"/>
          <ac:spMkLst>
            <pc:docMk/>
            <pc:sldMk cId="3070381831" sldId="259"/>
            <ac:spMk id="10" creationId="{1662D8F5-9195-8A0A-6F01-4950394E662E}"/>
          </ac:spMkLst>
        </pc:spChg>
        <pc:spChg chg="mod">
          <ac:chgData name="Mette Amalie Nebsbjerg" userId="49cc1974-8113-4dc3-957b-d53c518f6152" providerId="ADAL" clId="{C4029A96-ED16-4068-B8E2-B5AEFA90D7C7}" dt="2023-08-24T13:53:58.914" v="60" actId="20577"/>
          <ac:spMkLst>
            <pc:docMk/>
            <pc:sldMk cId="3070381831" sldId="259"/>
            <ac:spMk id="23" creationId="{4195966D-404C-1B98-BF61-6D3D6C3393A8}"/>
          </ac:spMkLst>
        </pc:spChg>
        <pc:spChg chg="mod">
          <ac:chgData name="Mette Amalie Nebsbjerg" userId="49cc1974-8113-4dc3-957b-d53c518f6152" providerId="ADAL" clId="{C4029A96-ED16-4068-B8E2-B5AEFA90D7C7}" dt="2023-08-24T13:53:43.693" v="33" actId="20577"/>
          <ac:spMkLst>
            <pc:docMk/>
            <pc:sldMk cId="3070381831" sldId="259"/>
            <ac:spMk id="24" creationId="{65BC4884-FE6D-84D1-E469-DE4576F01D6E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 mod">
              <pc226:chgData name="Mette Amalie Nebsbjerg" userId="49cc1974-8113-4dc3-957b-d53c518f6152" providerId="ADAL" clId="{C4029A96-ED16-4068-B8E2-B5AEFA90D7C7}" dt="2023-08-24T13:53:18.879" v="18"/>
              <pc2:cmMkLst xmlns:pc2="http://schemas.microsoft.com/office/powerpoint/2019/9/main/command">
                <pc:docMk/>
                <pc:sldMk cId="3070381831" sldId="259"/>
                <pc2:cmMk id="{DCF3489A-DCD8-44E1-9C03-4B589F70CFDE}"/>
              </pc2:cmMkLst>
            </pc226:cmChg>
          </p:ext>
        </pc:ext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847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3535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085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9307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134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60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6722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240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368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105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202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1A203-C1CA-4FD1-B737-C5A2EFF1E496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67573-7C22-4ECD-9FD7-9BCA6FB5A4D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59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>
            <a:extLst>
              <a:ext uri="{FF2B5EF4-FFF2-40B4-BE49-F238E27FC236}">
                <a16:creationId xmlns:a16="http://schemas.microsoft.com/office/drawing/2014/main" id="{99D624C8-9796-9372-D777-1E3CD2E1E74B}"/>
              </a:ext>
            </a:extLst>
          </p:cNvPr>
          <p:cNvSpPr txBox="1"/>
          <p:nvPr/>
        </p:nvSpPr>
        <p:spPr>
          <a:xfrm>
            <a:off x="423046" y="875008"/>
            <a:ext cx="286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ppendix 2. Data collection  </a:t>
            </a: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9479F0B9-FEBF-D449-2280-BD42F666176A}"/>
              </a:ext>
            </a:extLst>
          </p:cNvPr>
          <p:cNvSpPr/>
          <p:nvPr/>
        </p:nvSpPr>
        <p:spPr>
          <a:xfrm>
            <a:off x="2293861" y="1431325"/>
            <a:ext cx="2210868" cy="9252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Video contacts 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22,121</a:t>
            </a:r>
            <a:endParaRPr lang="en-GB" dirty="0"/>
          </a:p>
        </p:txBody>
      </p:sp>
      <p:cxnSp>
        <p:nvCxnSpPr>
          <p:cNvPr id="6" name="Lige pilforbindelse 5">
            <a:extLst>
              <a:ext uri="{FF2B5EF4-FFF2-40B4-BE49-F238E27FC236}">
                <a16:creationId xmlns:a16="http://schemas.microsoft.com/office/drawing/2014/main" id="{67FF5653-DA97-EEAA-9D31-D182EFFEA408}"/>
              </a:ext>
            </a:extLst>
          </p:cNvPr>
          <p:cNvCxnSpPr>
            <a:cxnSpLocks/>
          </p:cNvCxnSpPr>
          <p:nvPr/>
        </p:nvCxnSpPr>
        <p:spPr>
          <a:xfrm>
            <a:off x="3429000" y="3350857"/>
            <a:ext cx="686723" cy="9386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Lige pilforbindelse 6">
            <a:extLst>
              <a:ext uri="{FF2B5EF4-FFF2-40B4-BE49-F238E27FC236}">
                <a16:creationId xmlns:a16="http://schemas.microsoft.com/office/drawing/2014/main" id="{E20B771E-343B-3C12-83F5-BC672CE5D246}"/>
              </a:ext>
            </a:extLst>
          </p:cNvPr>
          <p:cNvCxnSpPr>
            <a:cxnSpLocks/>
          </p:cNvCxnSpPr>
          <p:nvPr/>
        </p:nvCxnSpPr>
        <p:spPr>
          <a:xfrm>
            <a:off x="3458707" y="3025256"/>
            <a:ext cx="1105433" cy="66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ktangel 9">
            <a:extLst>
              <a:ext uri="{FF2B5EF4-FFF2-40B4-BE49-F238E27FC236}">
                <a16:creationId xmlns:a16="http://schemas.microsoft.com/office/drawing/2014/main" id="{1662D8F5-9195-8A0A-6F01-4950394E662E}"/>
              </a:ext>
            </a:extLst>
          </p:cNvPr>
          <p:cNvSpPr/>
          <p:nvPr/>
        </p:nvSpPr>
        <p:spPr>
          <a:xfrm>
            <a:off x="4564140" y="2584416"/>
            <a:ext cx="2210867" cy="8950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Excluded due to missing identification number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28</a:t>
            </a:r>
          </a:p>
        </p:txBody>
      </p:sp>
      <p:cxnSp>
        <p:nvCxnSpPr>
          <p:cNvPr id="14" name="Lige pilforbindelse 13">
            <a:extLst>
              <a:ext uri="{FF2B5EF4-FFF2-40B4-BE49-F238E27FC236}">
                <a16:creationId xmlns:a16="http://schemas.microsoft.com/office/drawing/2014/main" id="{F594FECA-AFFD-88B7-3999-B5D09E8EB430}"/>
              </a:ext>
            </a:extLst>
          </p:cNvPr>
          <p:cNvCxnSpPr>
            <a:cxnSpLocks/>
          </p:cNvCxnSpPr>
          <p:nvPr/>
        </p:nvCxnSpPr>
        <p:spPr>
          <a:xfrm flipH="1">
            <a:off x="2750626" y="3362731"/>
            <a:ext cx="674255" cy="9076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Lige forbindelse 17">
            <a:extLst>
              <a:ext uri="{FF2B5EF4-FFF2-40B4-BE49-F238E27FC236}">
                <a16:creationId xmlns:a16="http://schemas.microsoft.com/office/drawing/2014/main" id="{31F6E2B2-CEB6-8B23-4429-8E54CFB16706}"/>
              </a:ext>
            </a:extLst>
          </p:cNvPr>
          <p:cNvCxnSpPr>
            <a:cxnSpLocks/>
          </p:cNvCxnSpPr>
          <p:nvPr/>
        </p:nvCxnSpPr>
        <p:spPr>
          <a:xfrm>
            <a:off x="3429000" y="2356527"/>
            <a:ext cx="0" cy="10077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ktangel 22">
            <a:extLst>
              <a:ext uri="{FF2B5EF4-FFF2-40B4-BE49-F238E27FC236}">
                <a16:creationId xmlns:a16="http://schemas.microsoft.com/office/drawing/2014/main" id="{4195966D-404C-1B98-BF61-6D3D6C3393A8}"/>
              </a:ext>
            </a:extLst>
          </p:cNvPr>
          <p:cNvSpPr/>
          <p:nvPr/>
        </p:nvSpPr>
        <p:spPr>
          <a:xfrm>
            <a:off x="4115723" y="4289464"/>
            <a:ext cx="2210868" cy="914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Contacts with participating triage GPs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16,291</a:t>
            </a:r>
          </a:p>
        </p:txBody>
      </p:sp>
      <p:sp>
        <p:nvSpPr>
          <p:cNvPr id="24" name="Rektangel 23">
            <a:extLst>
              <a:ext uri="{FF2B5EF4-FFF2-40B4-BE49-F238E27FC236}">
                <a16:creationId xmlns:a16="http://schemas.microsoft.com/office/drawing/2014/main" id="{65BC4884-FE6D-84D1-E469-DE4576F01D6E}"/>
              </a:ext>
            </a:extLst>
          </p:cNvPr>
          <p:cNvSpPr/>
          <p:nvPr/>
        </p:nvSpPr>
        <p:spPr>
          <a:xfrm>
            <a:off x="531409" y="4288355"/>
            <a:ext cx="2210868" cy="914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Contacts with non-participating triage GPs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5,802</a:t>
            </a:r>
          </a:p>
        </p:txBody>
      </p:sp>
      <p:cxnSp>
        <p:nvCxnSpPr>
          <p:cNvPr id="27" name="Lige pilforbindelse 26">
            <a:extLst>
              <a:ext uri="{FF2B5EF4-FFF2-40B4-BE49-F238E27FC236}">
                <a16:creationId xmlns:a16="http://schemas.microsoft.com/office/drawing/2014/main" id="{B8BE4858-3836-B621-23B9-DEBC9627B7B3}"/>
              </a:ext>
            </a:extLst>
          </p:cNvPr>
          <p:cNvCxnSpPr>
            <a:cxnSpLocks/>
          </p:cNvCxnSpPr>
          <p:nvPr/>
        </p:nvCxnSpPr>
        <p:spPr>
          <a:xfrm>
            <a:off x="4504729" y="5846803"/>
            <a:ext cx="389005" cy="6128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Lige pilforbindelse 27">
            <a:extLst>
              <a:ext uri="{FF2B5EF4-FFF2-40B4-BE49-F238E27FC236}">
                <a16:creationId xmlns:a16="http://schemas.microsoft.com/office/drawing/2014/main" id="{9A13FA09-6AEC-37E1-DFE1-D2E2823ED87A}"/>
              </a:ext>
            </a:extLst>
          </p:cNvPr>
          <p:cNvCxnSpPr>
            <a:cxnSpLocks/>
          </p:cNvCxnSpPr>
          <p:nvPr/>
        </p:nvCxnSpPr>
        <p:spPr>
          <a:xfrm flipH="1">
            <a:off x="4115723" y="5859698"/>
            <a:ext cx="389005" cy="5870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Lige forbindelse 28">
            <a:extLst>
              <a:ext uri="{FF2B5EF4-FFF2-40B4-BE49-F238E27FC236}">
                <a16:creationId xmlns:a16="http://schemas.microsoft.com/office/drawing/2014/main" id="{E63D6D66-9FE6-E7D6-D342-6C5AAB5E1D07}"/>
              </a:ext>
            </a:extLst>
          </p:cNvPr>
          <p:cNvCxnSpPr>
            <a:cxnSpLocks/>
          </p:cNvCxnSpPr>
          <p:nvPr/>
        </p:nvCxnSpPr>
        <p:spPr>
          <a:xfrm>
            <a:off x="4504728" y="5202755"/>
            <a:ext cx="0" cy="6440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ktangel 32">
            <a:extLst>
              <a:ext uri="{FF2B5EF4-FFF2-40B4-BE49-F238E27FC236}">
                <a16:creationId xmlns:a16="http://schemas.microsoft.com/office/drawing/2014/main" id="{6F209AFC-5092-3DDB-DB5E-0E9A1D6EEF4C}"/>
              </a:ext>
            </a:extLst>
          </p:cNvPr>
          <p:cNvSpPr/>
          <p:nvPr/>
        </p:nvSpPr>
        <p:spPr>
          <a:xfrm>
            <a:off x="2293860" y="6485456"/>
            <a:ext cx="2210868" cy="9252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Pop-up questionnaire 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2,515</a:t>
            </a:r>
            <a:endParaRPr lang="en-GB" dirty="0"/>
          </a:p>
        </p:txBody>
      </p:sp>
      <p:cxnSp>
        <p:nvCxnSpPr>
          <p:cNvPr id="36" name="Lige pilforbindelse 35">
            <a:extLst>
              <a:ext uri="{FF2B5EF4-FFF2-40B4-BE49-F238E27FC236}">
                <a16:creationId xmlns:a16="http://schemas.microsoft.com/office/drawing/2014/main" id="{2C6B061C-59D9-79FE-9524-89768C9B7982}"/>
              </a:ext>
            </a:extLst>
          </p:cNvPr>
          <p:cNvCxnSpPr>
            <a:cxnSpLocks/>
          </p:cNvCxnSpPr>
          <p:nvPr/>
        </p:nvCxnSpPr>
        <p:spPr>
          <a:xfrm flipH="1">
            <a:off x="2781997" y="8160975"/>
            <a:ext cx="6470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ktangel 39">
            <a:extLst>
              <a:ext uri="{FF2B5EF4-FFF2-40B4-BE49-F238E27FC236}">
                <a16:creationId xmlns:a16="http://schemas.microsoft.com/office/drawing/2014/main" id="{04BB6E2A-7640-CD27-AE0B-21EFE4164083}"/>
              </a:ext>
            </a:extLst>
          </p:cNvPr>
          <p:cNvSpPr/>
          <p:nvPr/>
        </p:nvSpPr>
        <p:spPr>
          <a:xfrm>
            <a:off x="2306868" y="9016443"/>
            <a:ext cx="2210868" cy="9252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Included questionnaires 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2,456</a:t>
            </a:r>
            <a:endParaRPr lang="en-GB" dirty="0"/>
          </a:p>
        </p:txBody>
      </p:sp>
      <p:cxnSp>
        <p:nvCxnSpPr>
          <p:cNvPr id="41" name="Lige pilforbindelse 40">
            <a:extLst>
              <a:ext uri="{FF2B5EF4-FFF2-40B4-BE49-F238E27FC236}">
                <a16:creationId xmlns:a16="http://schemas.microsoft.com/office/drawing/2014/main" id="{A155E161-1E88-188D-0160-372C4FF01BBB}"/>
              </a:ext>
            </a:extLst>
          </p:cNvPr>
          <p:cNvCxnSpPr>
            <a:cxnSpLocks/>
          </p:cNvCxnSpPr>
          <p:nvPr/>
        </p:nvCxnSpPr>
        <p:spPr>
          <a:xfrm>
            <a:off x="3424881" y="7424769"/>
            <a:ext cx="4119" cy="15775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ktangel 10">
            <a:extLst>
              <a:ext uri="{FF2B5EF4-FFF2-40B4-BE49-F238E27FC236}">
                <a16:creationId xmlns:a16="http://schemas.microsoft.com/office/drawing/2014/main" id="{99741A5D-A9DB-DF37-3C29-F97C2B99F9EA}"/>
              </a:ext>
            </a:extLst>
          </p:cNvPr>
          <p:cNvSpPr/>
          <p:nvPr/>
        </p:nvSpPr>
        <p:spPr>
          <a:xfrm>
            <a:off x="4541392" y="6485456"/>
            <a:ext cx="2210868" cy="9252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No pop-up questionnaire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13,776</a:t>
            </a:r>
            <a:endParaRPr lang="en-GB" sz="1400" dirty="0"/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E5180D6A-779D-05C1-67E5-612AD78E7570}"/>
              </a:ext>
            </a:extLst>
          </p:cNvPr>
          <p:cNvSpPr/>
          <p:nvPr/>
        </p:nvSpPr>
        <p:spPr>
          <a:xfrm>
            <a:off x="571129" y="7698374"/>
            <a:ext cx="2210868" cy="9252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Invalid questionnaires 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n=59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070381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07</TotalTime>
  <Words>56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ette Amalie Nebsbjerg</dc:creator>
  <cp:lastModifiedBy>Mette Amalie Nebsbjerg</cp:lastModifiedBy>
  <cp:revision>16</cp:revision>
  <dcterms:created xsi:type="dcterms:W3CDTF">2023-06-08T13:20:54Z</dcterms:created>
  <dcterms:modified xsi:type="dcterms:W3CDTF">2023-08-24T13:54:08Z</dcterms:modified>
</cp:coreProperties>
</file>